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56" r:id="rId2"/>
  </p:sldIdLst>
  <p:sldSz cx="6858000" cy="9906000" type="A4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00" autoAdjust="0"/>
    <p:restoredTop sz="94660"/>
  </p:normalViewPr>
  <p:slideViewPr>
    <p:cSldViewPr snapToGrid="0">
      <p:cViewPr varScale="1">
        <p:scale>
          <a:sx n="46" d="100"/>
          <a:sy n="46" d="100"/>
        </p:scale>
        <p:origin x="2212" y="4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C01E89B-B2A4-4A54-A9EA-3E137104F03A}" type="datetimeFigureOut">
              <a:rPr kumimoji="1" lang="ja-JP" altLang="en-US" smtClean="0"/>
              <a:t>2020/1/12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0001422-DDA8-4BD1-A1D4-D21D49F19CD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2411866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0001422-DDA8-4BD1-A1D4-D21D49F19CD7}" type="slidenum">
              <a:rPr kumimoji="1" lang="ja-JP" altLang="en-US" smtClean="0"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9377223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5B96B4-4F09-4857-B9C6-6578BE1EDCB3}" type="datetime1">
              <a:rPr kumimoji="1" lang="ja-JP" altLang="en-US" smtClean="0"/>
              <a:t>2020/1/1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kumimoji="1" lang="en-US" altLang="ja-JP"/>
              <a:t>Kawashima M et al.</a:t>
            </a:r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AB5EA2-2834-4F7A-A091-F103526DC19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5171505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5A6910-78B8-40D0-91CB-5CBE9E443429}" type="datetime1">
              <a:rPr kumimoji="1" lang="ja-JP" altLang="en-US" smtClean="0"/>
              <a:t>2020/1/1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kumimoji="1" lang="en-US" altLang="ja-JP"/>
              <a:t>Kawashima M et al.</a:t>
            </a:r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AB5EA2-2834-4F7A-A091-F103526DC19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9252863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6B63CB-BEBE-4D68-9A2C-095B8365D572}" type="datetime1">
              <a:rPr kumimoji="1" lang="ja-JP" altLang="en-US" smtClean="0"/>
              <a:t>2020/1/1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kumimoji="1" lang="en-US" altLang="ja-JP"/>
              <a:t>Kawashima M et al.</a:t>
            </a:r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AB5EA2-2834-4F7A-A091-F103526DC19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8495742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63D547-8737-4304-89FA-A00D7AA8D182}" type="datetime1">
              <a:rPr kumimoji="1" lang="ja-JP" altLang="en-US" smtClean="0"/>
              <a:t>2020/1/1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kumimoji="1" lang="en-US" altLang="ja-JP"/>
              <a:t>Kawashima M et al.</a:t>
            </a:r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AB5EA2-2834-4F7A-A091-F103526DC19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8303222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EEE752-DD06-4D82-B746-7DF9AB02AFCD}" type="datetime1">
              <a:rPr kumimoji="1" lang="ja-JP" altLang="en-US" smtClean="0"/>
              <a:t>2020/1/1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kumimoji="1" lang="en-US" altLang="ja-JP"/>
              <a:t>Kawashima M et al.</a:t>
            </a:r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AB5EA2-2834-4F7A-A091-F103526DC19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8811832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FDE446-1402-42F4-9176-A428C3AD673E}" type="datetime1">
              <a:rPr kumimoji="1" lang="ja-JP" altLang="en-US" smtClean="0"/>
              <a:t>2020/1/12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kumimoji="1" lang="en-US" altLang="ja-JP"/>
              <a:t>Kawashima M et al.</a:t>
            </a:r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AB5EA2-2834-4F7A-A091-F103526DC19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0700505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B5B6E5-F8D3-40B5-8EF4-32EB90941236}" type="datetime1">
              <a:rPr kumimoji="1" lang="ja-JP" altLang="en-US" smtClean="0"/>
              <a:t>2020/1/12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kumimoji="1" lang="en-US" altLang="ja-JP"/>
              <a:t>Kawashima M et al.</a:t>
            </a:r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AB5EA2-2834-4F7A-A091-F103526DC19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078619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9BB4D0-7858-47F4-8CC5-0B77BD42C34D}" type="datetime1">
              <a:rPr kumimoji="1" lang="ja-JP" altLang="en-US" smtClean="0"/>
              <a:t>2020/1/12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kumimoji="1" lang="en-US" altLang="ja-JP"/>
              <a:t>Kawashima M et al.</a:t>
            </a:r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AB5EA2-2834-4F7A-A091-F103526DC19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0391482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8577D9-E395-4416-8DDC-4EC2FB68191E}" type="datetime1">
              <a:rPr kumimoji="1" lang="ja-JP" altLang="en-US" smtClean="0"/>
              <a:t>2020/1/12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kumimoji="1" lang="en-US" altLang="ja-JP"/>
              <a:t>Kawashima M et al.</a:t>
            </a:r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AB5EA2-2834-4F7A-A091-F103526DC19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6510449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053AFB-4874-478B-A8D4-653F1D162A85}" type="datetime1">
              <a:rPr kumimoji="1" lang="ja-JP" altLang="en-US" smtClean="0"/>
              <a:t>2020/1/12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kumimoji="1" lang="en-US" altLang="ja-JP"/>
              <a:t>Kawashima M et al.</a:t>
            </a:r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AB5EA2-2834-4F7A-A091-F103526DC19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4972879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6EC606-BBBD-4114-8922-3B83D8437D2A}" type="datetime1">
              <a:rPr kumimoji="1" lang="ja-JP" altLang="en-US" smtClean="0"/>
              <a:t>2020/1/12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kumimoji="1" lang="en-US" altLang="ja-JP"/>
              <a:t>Kawashima M et al.</a:t>
            </a:r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AB5EA2-2834-4F7A-A091-F103526DC19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6977273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F16FA05-DD13-4442-AACF-F433BF571309}" type="datetime1">
              <a:rPr kumimoji="1" lang="ja-JP" altLang="en-US" smtClean="0"/>
              <a:t>2020/1/1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r>
              <a:rPr kumimoji="1" lang="en-US" altLang="ja-JP"/>
              <a:t>Kawashima M et al.</a:t>
            </a:r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3AB5EA2-2834-4F7A-A091-F103526DC19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4927706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hf hdr="0" dt="0"/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3.tif"/><Relationship Id="rId4" Type="http://schemas.openxmlformats.org/officeDocument/2006/relationships/image" Target="../media/image2.ti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/>
          <p:cNvSpPr txBox="1"/>
          <p:nvPr/>
        </p:nvSpPr>
        <p:spPr>
          <a:xfrm>
            <a:off x="526091" y="938618"/>
            <a:ext cx="78579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Fig. S4</a:t>
            </a:r>
            <a:endParaRPr kumimoji="1" lang="ja-JP" altLang="en-US" dirty="0"/>
          </a:p>
        </p:txBody>
      </p:sp>
      <p:sp>
        <p:nvSpPr>
          <p:cNvPr id="7" name="フッター プレースホルダー 6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kumimoji="1" lang="en-US" altLang="ja-JP"/>
              <a:t>Kawashima M et al.</a:t>
            </a:r>
            <a:endParaRPr kumimoji="1" lang="ja-JP" altLang="en-US"/>
          </a:p>
        </p:txBody>
      </p:sp>
      <p:sp>
        <p:nvSpPr>
          <p:cNvPr id="3" name="正方形/長方形 2"/>
          <p:cNvSpPr/>
          <p:nvPr/>
        </p:nvSpPr>
        <p:spPr>
          <a:xfrm>
            <a:off x="918987" y="3535779"/>
            <a:ext cx="5213073" cy="83099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1200" dirty="0"/>
              <a:t>Immunofluorescent image of UCP1 positive cells. To increase the sensitivity of Mito tracker, </a:t>
            </a:r>
            <a:r>
              <a:rPr lang="en-US" altLang="ja-JP" sz="1200" dirty="0" err="1"/>
              <a:t>mitochondoria</a:t>
            </a:r>
            <a:r>
              <a:rPr lang="en-US" altLang="ja-JP" sz="1200" dirty="0"/>
              <a:t> were stained with higher concentration of Mito tracker. Co-localization of UCP1 (green) and Mito tracker (magenta) was recognized as white signals (indicated by white arrows). </a:t>
            </a:r>
          </a:p>
        </p:txBody>
      </p:sp>
      <p:grpSp>
        <p:nvGrpSpPr>
          <p:cNvPr id="2" name="グループ化 1"/>
          <p:cNvGrpSpPr/>
          <p:nvPr/>
        </p:nvGrpSpPr>
        <p:grpSpPr>
          <a:xfrm>
            <a:off x="756385" y="1422628"/>
            <a:ext cx="5213073" cy="1852448"/>
            <a:chOff x="462372" y="1197753"/>
            <a:chExt cx="8471171" cy="3010201"/>
          </a:xfrm>
        </p:grpSpPr>
        <p:pic>
          <p:nvPicPr>
            <p:cNvPr id="44" name="図 43"/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21702" r="24519" b="11814"/>
            <a:stretch/>
          </p:blipFill>
          <p:spPr>
            <a:xfrm>
              <a:off x="6140489" y="1719940"/>
              <a:ext cx="2793054" cy="2460128"/>
            </a:xfrm>
            <a:prstGeom prst="rect">
              <a:avLst/>
            </a:prstGeom>
          </p:spPr>
        </p:pic>
        <p:pic>
          <p:nvPicPr>
            <p:cNvPr id="45" name="図 44"/>
            <p:cNvPicPr>
              <a:picLocks noChangeAspect="1"/>
            </p:cNvPicPr>
            <p:nvPr/>
          </p:nvPicPr>
          <p:blipFill rotWithShape="1"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21978" r="23970" b="11538"/>
            <a:stretch/>
          </p:blipFill>
          <p:spPr>
            <a:xfrm>
              <a:off x="462372" y="1719940"/>
              <a:ext cx="2813385" cy="2460127"/>
            </a:xfrm>
            <a:prstGeom prst="rect">
              <a:avLst/>
            </a:prstGeom>
          </p:spPr>
        </p:pic>
        <p:pic>
          <p:nvPicPr>
            <p:cNvPr id="46" name="図 45"/>
            <p:cNvPicPr>
              <a:picLocks noChangeAspect="1"/>
            </p:cNvPicPr>
            <p:nvPr/>
          </p:nvPicPr>
          <p:blipFill rotWithShape="1"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21977" r="24245" b="11538"/>
            <a:stretch/>
          </p:blipFill>
          <p:spPr>
            <a:xfrm>
              <a:off x="3306513" y="1719941"/>
              <a:ext cx="2803220" cy="2460127"/>
            </a:xfrm>
            <a:prstGeom prst="rect">
              <a:avLst/>
            </a:prstGeom>
          </p:spPr>
        </p:pic>
        <p:sp>
          <p:nvSpPr>
            <p:cNvPr id="47" name="テキスト ボックス 46"/>
            <p:cNvSpPr txBox="1"/>
            <p:nvPr/>
          </p:nvSpPr>
          <p:spPr>
            <a:xfrm>
              <a:off x="1350445" y="1197755"/>
              <a:ext cx="1032043" cy="55014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kumimoji="1" lang="en-US" altLang="ja-JP" sz="1600" dirty="0">
                  <a:solidFill>
                    <a:srgbClr val="00B050"/>
                  </a:solidFill>
                </a:rPr>
                <a:t>UCP1</a:t>
              </a:r>
              <a:endParaRPr kumimoji="1" lang="ja-JP" altLang="en-US" sz="1600" dirty="0">
                <a:solidFill>
                  <a:srgbClr val="00B050"/>
                </a:solidFill>
              </a:endParaRPr>
            </a:p>
          </p:txBody>
        </p:sp>
        <p:sp>
          <p:nvSpPr>
            <p:cNvPr id="48" name="テキスト ボックス 47"/>
            <p:cNvSpPr txBox="1"/>
            <p:nvPr/>
          </p:nvSpPr>
          <p:spPr>
            <a:xfrm>
              <a:off x="3724528" y="1197753"/>
              <a:ext cx="1967189" cy="55014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1600" dirty="0">
                  <a:solidFill>
                    <a:srgbClr val="7030A0"/>
                  </a:solidFill>
                </a:rPr>
                <a:t>Mito tracker</a:t>
              </a:r>
              <a:endParaRPr kumimoji="1" lang="ja-JP" altLang="en-US" sz="1600" dirty="0">
                <a:solidFill>
                  <a:srgbClr val="7030A0"/>
                </a:solidFill>
              </a:endParaRPr>
            </a:p>
          </p:txBody>
        </p:sp>
        <p:sp>
          <p:nvSpPr>
            <p:cNvPr id="49" name="テキスト ボックス 48"/>
            <p:cNvSpPr txBox="1"/>
            <p:nvPr/>
          </p:nvSpPr>
          <p:spPr>
            <a:xfrm>
              <a:off x="6846562" y="1197753"/>
              <a:ext cx="1183542" cy="55014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1600" dirty="0"/>
                <a:t>Merge</a:t>
              </a:r>
              <a:endParaRPr kumimoji="1" lang="ja-JP" altLang="en-US" sz="1600" dirty="0"/>
            </a:p>
          </p:txBody>
        </p:sp>
        <p:sp>
          <p:nvSpPr>
            <p:cNvPr id="50" name="右矢印 49"/>
            <p:cNvSpPr/>
            <p:nvPr/>
          </p:nvSpPr>
          <p:spPr>
            <a:xfrm rot="8269132">
              <a:off x="8410466" y="2644409"/>
              <a:ext cx="251042" cy="46734"/>
            </a:xfrm>
            <a:prstGeom prst="rightArrow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2000"/>
            </a:p>
          </p:txBody>
        </p:sp>
        <p:sp>
          <p:nvSpPr>
            <p:cNvPr id="51" name="テキスト ボックス 50"/>
            <p:cNvSpPr txBox="1"/>
            <p:nvPr/>
          </p:nvSpPr>
          <p:spPr>
            <a:xfrm>
              <a:off x="6168819" y="3763066"/>
              <a:ext cx="1108049" cy="44488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1400" dirty="0">
                  <a:solidFill>
                    <a:srgbClr val="0070C0"/>
                  </a:solidFill>
                </a:rPr>
                <a:t>Nucleus</a:t>
              </a:r>
              <a:endParaRPr kumimoji="1" lang="ja-JP" altLang="en-US" sz="1400" dirty="0">
                <a:solidFill>
                  <a:srgbClr val="0070C0"/>
                </a:solidFill>
              </a:endParaRPr>
            </a:p>
          </p:txBody>
        </p:sp>
        <p:cxnSp>
          <p:nvCxnSpPr>
            <p:cNvPr id="52" name="直線コネクタ 51"/>
            <p:cNvCxnSpPr/>
            <p:nvPr/>
          </p:nvCxnSpPr>
          <p:spPr>
            <a:xfrm>
              <a:off x="8387211" y="4046760"/>
              <a:ext cx="298800" cy="1"/>
            </a:xfrm>
            <a:prstGeom prst="line">
              <a:avLst/>
            </a:prstGeom>
            <a:ln w="28575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3" name="テキスト ボックス 52"/>
            <p:cNvSpPr txBox="1"/>
            <p:nvPr/>
          </p:nvSpPr>
          <p:spPr>
            <a:xfrm>
              <a:off x="8177038" y="3690174"/>
              <a:ext cx="728040" cy="3670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050" dirty="0">
                  <a:solidFill>
                    <a:schemeClr val="bg1"/>
                  </a:solidFill>
                </a:rPr>
                <a:t>10</a:t>
              </a:r>
              <a:r>
                <a:rPr kumimoji="1" lang="el-GR" altLang="ja-JP" sz="1050" dirty="0">
                  <a:solidFill>
                    <a:schemeClr val="bg1"/>
                  </a:solidFill>
                </a:rPr>
                <a:t>μ</a:t>
              </a:r>
              <a:r>
                <a:rPr kumimoji="1" lang="en-US" altLang="ja-JP" sz="1050" dirty="0">
                  <a:solidFill>
                    <a:schemeClr val="bg1"/>
                  </a:solidFill>
                </a:rPr>
                <a:t>m</a:t>
              </a:r>
              <a:endParaRPr kumimoji="1" lang="ja-JP" altLang="en-US" sz="1050" dirty="0">
                <a:solidFill>
                  <a:schemeClr val="bg1"/>
                </a:solidFill>
              </a:endParaRPr>
            </a:p>
          </p:txBody>
        </p:sp>
        <p:sp>
          <p:nvSpPr>
            <p:cNvPr id="54" name="右矢印 53"/>
            <p:cNvSpPr/>
            <p:nvPr/>
          </p:nvSpPr>
          <p:spPr>
            <a:xfrm rot="2030183">
              <a:off x="6890029" y="3269384"/>
              <a:ext cx="251042" cy="46734"/>
            </a:xfrm>
            <a:prstGeom prst="rightArrow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2000"/>
            </a:p>
          </p:txBody>
        </p:sp>
        <p:sp>
          <p:nvSpPr>
            <p:cNvPr id="55" name="右矢印 54"/>
            <p:cNvSpPr/>
            <p:nvPr/>
          </p:nvSpPr>
          <p:spPr>
            <a:xfrm rot="12566748">
              <a:off x="7786868" y="3231116"/>
              <a:ext cx="251042" cy="46734"/>
            </a:xfrm>
            <a:prstGeom prst="rightArrow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2000"/>
            </a:p>
          </p:txBody>
        </p:sp>
      </p:grpSp>
    </p:spTree>
    <p:extLst>
      <p:ext uri="{BB962C8B-B14F-4D97-AF65-F5344CB8AC3E}">
        <p14:creationId xmlns:p14="http://schemas.microsoft.com/office/powerpoint/2010/main" val="105121676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5852</TotalTime>
  <Words>65</Words>
  <Application>Microsoft Office PowerPoint</Application>
  <PresentationFormat>A4 210 x 297 mm</PresentationFormat>
  <Paragraphs>9</Paragraphs>
  <Slides>1</Slides>
  <Notes>1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Masahiro Kawashima</dc:creator>
  <cp:lastModifiedBy>Kawashima Masahiro</cp:lastModifiedBy>
  <cp:revision>116</cp:revision>
  <dcterms:created xsi:type="dcterms:W3CDTF">2017-03-29T14:34:10Z</dcterms:created>
  <dcterms:modified xsi:type="dcterms:W3CDTF">2020-01-11T16:46:27Z</dcterms:modified>
</cp:coreProperties>
</file>